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45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8C4F8-0DD3-4EC1-89A9-1C29282C65E6}" type="datetimeFigureOut">
              <a:rPr lang="en-US" smtClean="0"/>
              <a:t>8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D8616-E1DB-49CF-8CCF-8642A836B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40947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8C4F8-0DD3-4EC1-89A9-1C29282C65E6}" type="datetimeFigureOut">
              <a:rPr lang="en-US" smtClean="0"/>
              <a:t>8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D8616-E1DB-49CF-8CCF-8642A836B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84170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8C4F8-0DD3-4EC1-89A9-1C29282C65E6}" type="datetimeFigureOut">
              <a:rPr lang="en-US" smtClean="0"/>
              <a:t>8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D8616-E1DB-49CF-8CCF-8642A836B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64975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8C4F8-0DD3-4EC1-89A9-1C29282C65E6}" type="datetimeFigureOut">
              <a:rPr lang="en-US" smtClean="0"/>
              <a:t>8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D8616-E1DB-49CF-8CCF-8642A836B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45174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8C4F8-0DD3-4EC1-89A9-1C29282C65E6}" type="datetimeFigureOut">
              <a:rPr lang="en-US" smtClean="0"/>
              <a:t>8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D8616-E1DB-49CF-8CCF-8642A836B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89294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8C4F8-0DD3-4EC1-89A9-1C29282C65E6}" type="datetimeFigureOut">
              <a:rPr lang="en-US" smtClean="0"/>
              <a:t>8/1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D8616-E1DB-49CF-8CCF-8642A836B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52531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8C4F8-0DD3-4EC1-89A9-1C29282C65E6}" type="datetimeFigureOut">
              <a:rPr lang="en-US" smtClean="0"/>
              <a:t>8/11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D8616-E1DB-49CF-8CCF-8642A836B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07510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8C4F8-0DD3-4EC1-89A9-1C29282C65E6}" type="datetimeFigureOut">
              <a:rPr lang="en-US" smtClean="0"/>
              <a:t>8/11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D8616-E1DB-49CF-8CCF-8642A836B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24095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8C4F8-0DD3-4EC1-89A9-1C29282C65E6}" type="datetimeFigureOut">
              <a:rPr lang="en-US" smtClean="0"/>
              <a:t>8/11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D8616-E1DB-49CF-8CCF-8642A836B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09217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8C4F8-0DD3-4EC1-89A9-1C29282C65E6}" type="datetimeFigureOut">
              <a:rPr lang="en-US" smtClean="0"/>
              <a:t>8/1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D8616-E1DB-49CF-8CCF-8642A836B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15092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8C4F8-0DD3-4EC1-89A9-1C29282C65E6}" type="datetimeFigureOut">
              <a:rPr lang="en-US" smtClean="0"/>
              <a:t>8/1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D8616-E1DB-49CF-8CCF-8642A836B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88135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38C4F8-0DD3-4EC1-89A9-1C29282C65E6}" type="datetimeFigureOut">
              <a:rPr lang="en-US" smtClean="0"/>
              <a:t>8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7D8616-E1DB-49CF-8CCF-8642A836B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83605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2398143" y="741872"/>
            <a:ext cx="7384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README </a:t>
            </a:r>
            <a:r>
              <a:rPr lang="en-US" dirty="0"/>
              <a:t>- Fig 1R </a:t>
            </a:r>
            <a:r>
              <a:rPr lang="en-US" dirty="0" smtClean="0"/>
              <a:t>WT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1906436" y="1620163"/>
            <a:ext cx="8402126" cy="36933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>
              <a:buAutoNum type="arabicPeriod"/>
            </a:pPr>
            <a:r>
              <a:rPr lang="en-US" dirty="0" smtClean="0"/>
              <a:t>Perform a blind analysis of gephyrin and spine density and size from 12 WT cells.</a:t>
            </a:r>
          </a:p>
          <a:p>
            <a:pPr marL="342900" indent="-342900">
              <a:buAutoNum type="arabicPeriod"/>
            </a:pPr>
            <a:endParaRPr lang="en-US" dirty="0" smtClean="0"/>
          </a:p>
          <a:p>
            <a:pPr marL="342900" indent="-342900">
              <a:buAutoNum type="arabicPeriod"/>
            </a:pPr>
            <a:r>
              <a:rPr lang="en-US" dirty="0" smtClean="0"/>
              <a:t>Randomly select a subset of cells whose gephyrin and spine measurements are closest to the group average.</a:t>
            </a:r>
          </a:p>
          <a:p>
            <a:pPr marL="342900" indent="-342900">
              <a:buAutoNum type="arabicPeriod"/>
            </a:pPr>
            <a:endParaRPr lang="en-US" dirty="0" smtClean="0"/>
          </a:p>
          <a:p>
            <a:pPr marL="342900" indent="-342900">
              <a:buAutoNum type="arabicPeriod"/>
            </a:pPr>
            <a:r>
              <a:rPr lang="en-US" dirty="0" smtClean="0"/>
              <a:t>From the selected cells, identify one ROI (dendritic segment) that is free of overlapping dendrites above or below the targeted region.</a:t>
            </a:r>
          </a:p>
          <a:p>
            <a:pPr marL="342900" indent="-342900">
              <a:buAutoNum type="arabicPeriod"/>
            </a:pPr>
            <a:endParaRPr lang="en-US" dirty="0" smtClean="0"/>
          </a:p>
          <a:p>
            <a:pPr marL="342900" indent="-342900">
              <a:buAutoNum type="arabicPeriod"/>
            </a:pPr>
            <a:r>
              <a:rPr lang="en-US" dirty="0" smtClean="0"/>
              <a:t>Crop the image at the center of the selected ROI to ensure clear visualization of gephyrin and spines. </a:t>
            </a:r>
          </a:p>
          <a:p>
            <a:pPr marL="342900" indent="-342900">
              <a:buAutoNum type="arabicPeriod"/>
            </a:pPr>
            <a:endParaRPr lang="en-US" dirty="0" smtClean="0"/>
          </a:p>
          <a:p>
            <a:pPr marL="342900" indent="-342900">
              <a:buAutoNum type="arabicPeriod"/>
            </a:pPr>
            <a:r>
              <a:rPr lang="en-US" dirty="0"/>
              <a:t>Generate a dual-color two-photon image stack (512 × 512 pixels, 0.047 µm/pixel resolution, 1 µm z-steps</a:t>
            </a:r>
            <a:r>
              <a:rPr lang="en-US" dirty="0" smtClean="0"/>
              <a:t>)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123705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</TotalTime>
  <Words>103</Words>
  <Application>Microsoft Office PowerPoint</Application>
  <PresentationFormat>Widescreen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CU Denver | Anschutz Medical Campu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on Chan Oh</dc:creator>
  <cp:lastModifiedBy>Won Chan Oh</cp:lastModifiedBy>
  <cp:revision>5</cp:revision>
  <dcterms:created xsi:type="dcterms:W3CDTF">2025-08-11T17:05:23Z</dcterms:created>
  <dcterms:modified xsi:type="dcterms:W3CDTF">2025-08-11T17:36:48Z</dcterms:modified>
</cp:coreProperties>
</file>